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CB"/>
    <a:srgbClr val="640000"/>
    <a:srgbClr val="8B0000"/>
    <a:srgbClr val="FF0000"/>
    <a:srgbClr val="FF6666"/>
    <a:srgbClr val="ED1B9D"/>
    <a:srgbClr val="ED2A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3" d="100"/>
          <a:sy n="73" d="100"/>
        </p:scale>
        <p:origin x="72" y="173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E57260-5E78-40A5-873F-87A00C01AD79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81FDFF-17D7-4321-AB20-5463807F33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8650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粉色、浅红、标准红、深红、暗红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81FDFF-17D7-4321-AB20-5463807F332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0212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0A9AE9-ABFB-73A0-BBEB-4ED2C8A0F8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ACD5546-EB70-614C-5FBC-56ED5566FA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FC87D12-4034-B5B7-089F-96255C05E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43969A-76D9-C3D7-E550-908BE628C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69030D-208A-E4D8-6946-84ED9326E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8639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D9F1F6-D36F-A6F9-CB51-133CAC4B4E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532A6BA-5A69-23F4-D0A4-C172D7BC9B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29B90A-95F6-79D2-4979-0E503A7D1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E395BA-0597-DFD7-69C8-037A710EE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5AF950-6CCD-9DF3-F239-82E6C2E35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076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2EFFECA-E41C-051B-F69B-28F4A4D8E4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EC4058-BA1D-74D8-82A8-F1CB84BCFB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738836-E007-9429-2FA2-4A31256B0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2767F6-FC30-AE86-6F14-31483A639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76CFD5-D6A5-9CFB-433B-57A920C97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719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B447BA-2D5A-FD68-D3D3-F4618B17F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394CA1A-478F-31D0-60A9-19F45442A1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8E9E50-0B09-FEF3-1A4D-0642348E4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66A930-B551-47AA-4E6F-00D5C4ADD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163EA-F361-981C-807A-51E9B35D7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569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96B8F9-CE3E-3BE8-1941-700594B9A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D755BE-10CD-8830-1F7A-2C120E05D2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836C6C-E79F-B0E3-0560-5152143DE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46757F-9ADB-A06C-C6C4-6C52F7344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A6BE11-CF6F-D42B-F251-126621D86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1413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56AF10-FC31-046F-3191-C4E4C59576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AAD68E-ACBA-160B-411D-FEFE694C76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60F58F6-4A46-227D-4922-3FA3255E2F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D35547-7A82-6F83-9A7F-38315F41B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B86268-0F38-CED5-7583-8984275CA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5C3A48-457C-348F-107E-1F89682EC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411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B56F96-C0CE-7496-DFE8-3717D0A57C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77992B6-6363-D9EA-7B31-43C656F931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82D6E37-7CDB-9A84-E2D9-FB679F37A5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54DE10D-C0F6-CA85-A401-2858D169E0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D3A7806-F85D-28E8-5B25-0EF5CB3800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E57ABCE-4387-B3E0-9E37-39FC072A9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133CDFE-7526-97D0-C0F8-6DF89A88F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672B949-6D95-B552-9C17-F29423381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96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A14203-52B4-99C0-B9B8-2CBE42C281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CEEED2D-F74C-CB52-0FA8-645313541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A3CB616-0613-DD49-D62E-264A0D3C4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CBAB858-ACAF-A0B3-324D-4E2FFBBBA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31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8E61A91-B869-CBA4-9819-39AADCCDF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64A73B0-FBFF-4E1C-BFC6-492E4CBDC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1FCC361-9057-EAE8-5148-1CB7CFDD1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176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7A1C6C-5626-86BF-749B-F1CD563CF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2E3D34-6E34-3CB8-EFAF-20BFC938CD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EFAEFCA-2C0B-9EAE-4E1C-8A70E647BB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C05B1BC-7729-50C0-DA6C-5EAA18DA4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C848E01-6141-8D35-BE96-F2A39DB7F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223D82-E139-C60C-37BD-4F66F2376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638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7CFA47-36C9-48CC-D8A2-AA004E0759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D123760-9505-040F-1A0F-D16A458DEA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585970-6F97-6ABC-FBC5-5890A5B715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1E1B25-781F-ADA3-735A-15E79DC87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86E771-E31C-1191-BEEA-633CB3F2C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5238E4A-3793-263A-0648-1DA926783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1978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AB6001B-8AA7-1ACE-740B-1923752B9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A6A8D81-0D57-3666-3BD2-A4A9D2925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411A1B-38B2-FAD1-F0A9-DC17126A33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02308-31F4-4D6B-9018-02D185F3A673}" type="datetimeFigureOut">
              <a:rPr lang="zh-CN" altLang="en-US" smtClean="0"/>
              <a:t>2025-07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925779-F7C2-1DE9-42AE-85AC6BD0CF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B0E751-7251-AED6-B793-A07A67BDF1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D6743-71F4-4B21-845A-031D274DB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5736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: 圆角 4">
            <a:extLst>
              <a:ext uri="{FF2B5EF4-FFF2-40B4-BE49-F238E27FC236}">
                <a16:creationId xmlns:a16="http://schemas.microsoft.com/office/drawing/2014/main" id="{5ABB6F20-5C54-53A5-9E42-05CBA648973B}"/>
              </a:ext>
            </a:extLst>
          </p:cNvPr>
          <p:cNvSpPr/>
          <p:nvPr/>
        </p:nvSpPr>
        <p:spPr>
          <a:xfrm>
            <a:off x="4456387" y="315656"/>
            <a:ext cx="2858814" cy="484022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/>
              <a:t>Uricase deficiency</a:t>
            </a:r>
            <a:endParaRPr lang="zh-CN" altLang="en-US" b="1" dirty="0"/>
          </a:p>
        </p:txBody>
      </p:sp>
      <p:sp>
        <p:nvSpPr>
          <p:cNvPr id="6" name="矩形: 圆角 5">
            <a:extLst>
              <a:ext uri="{FF2B5EF4-FFF2-40B4-BE49-F238E27FC236}">
                <a16:creationId xmlns:a16="http://schemas.microsoft.com/office/drawing/2014/main" id="{E3D6A17D-C7CC-6766-3AAC-CBC19C3CB235}"/>
              </a:ext>
            </a:extLst>
          </p:cNvPr>
          <p:cNvSpPr/>
          <p:nvPr/>
        </p:nvSpPr>
        <p:spPr>
          <a:xfrm>
            <a:off x="4456386" y="1174177"/>
            <a:ext cx="2858814" cy="529066"/>
          </a:xfrm>
          <a:prstGeom prst="roundRect">
            <a:avLst/>
          </a:prstGeom>
          <a:solidFill>
            <a:srgbClr val="FFC0CB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/>
              <a:t>Hyperuricemia</a:t>
            </a:r>
            <a:endParaRPr lang="zh-CN" altLang="en-US" b="1" dirty="0"/>
          </a:p>
        </p:txBody>
      </p:sp>
      <p:sp>
        <p:nvSpPr>
          <p:cNvPr id="7" name="矩形: 圆角 6">
            <a:extLst>
              <a:ext uri="{FF2B5EF4-FFF2-40B4-BE49-F238E27FC236}">
                <a16:creationId xmlns:a16="http://schemas.microsoft.com/office/drawing/2014/main" id="{EECB7294-4728-6076-719B-11FE6A466E61}"/>
              </a:ext>
            </a:extLst>
          </p:cNvPr>
          <p:cNvSpPr/>
          <p:nvPr/>
        </p:nvSpPr>
        <p:spPr>
          <a:xfrm>
            <a:off x="4456386" y="2097090"/>
            <a:ext cx="2858813" cy="1076643"/>
          </a:xfrm>
          <a:prstGeom prst="roundRect">
            <a:avLst/>
          </a:prstGeom>
          <a:solidFill>
            <a:srgbClr val="FF6666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/>
              <a:t>Inflammation,</a:t>
            </a:r>
            <a:r>
              <a:rPr lang="zh-CN" altLang="en-US" b="1" dirty="0"/>
              <a:t> </a:t>
            </a:r>
            <a:r>
              <a:rPr lang="en-US" altLang="zh-CN" b="1" dirty="0"/>
              <a:t>insulin resistance, diabetes, and hypercholesterolemia</a:t>
            </a:r>
            <a:endParaRPr lang="zh-CN" altLang="en-US" b="1" dirty="0"/>
          </a:p>
        </p:txBody>
      </p:sp>
      <p:sp>
        <p:nvSpPr>
          <p:cNvPr id="10" name="矩形: 圆角 9">
            <a:extLst>
              <a:ext uri="{FF2B5EF4-FFF2-40B4-BE49-F238E27FC236}">
                <a16:creationId xmlns:a16="http://schemas.microsoft.com/office/drawing/2014/main" id="{ABDCB9CB-2323-0EFF-1530-3A13C8A37C9C}"/>
              </a:ext>
            </a:extLst>
          </p:cNvPr>
          <p:cNvSpPr/>
          <p:nvPr/>
        </p:nvSpPr>
        <p:spPr>
          <a:xfrm>
            <a:off x="4435364" y="5441139"/>
            <a:ext cx="2858812" cy="529066"/>
          </a:xfrm>
          <a:prstGeom prst="roundRect">
            <a:avLst/>
          </a:prstGeom>
          <a:solidFill>
            <a:srgbClr val="64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/>
              <a:t>Death </a:t>
            </a:r>
            <a:endParaRPr lang="zh-CN" altLang="en-US" b="1" dirty="0"/>
          </a:p>
        </p:txBody>
      </p:sp>
      <p:sp>
        <p:nvSpPr>
          <p:cNvPr id="12" name="箭头: 虚尾 11">
            <a:extLst>
              <a:ext uri="{FF2B5EF4-FFF2-40B4-BE49-F238E27FC236}">
                <a16:creationId xmlns:a16="http://schemas.microsoft.com/office/drawing/2014/main" id="{BC8CF8DF-BBC4-E9CC-698E-E9F3787D71CB}"/>
              </a:ext>
            </a:extLst>
          </p:cNvPr>
          <p:cNvSpPr/>
          <p:nvPr/>
        </p:nvSpPr>
        <p:spPr>
          <a:xfrm rot="5400000">
            <a:off x="5697223" y="714812"/>
            <a:ext cx="335095" cy="536027"/>
          </a:xfrm>
          <a:prstGeom prst="striped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A0A3616-4B4C-5BEE-F859-1E57E6CD7F45}"/>
              </a:ext>
            </a:extLst>
          </p:cNvPr>
          <p:cNvSpPr txBox="1"/>
          <p:nvPr/>
        </p:nvSpPr>
        <p:spPr>
          <a:xfrm>
            <a:off x="6132785" y="1682954"/>
            <a:ext cx="15345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microcrystals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AEAACB6-80D8-81F5-9ABA-9A0065C4BB5B}"/>
              </a:ext>
            </a:extLst>
          </p:cNvPr>
          <p:cNvSpPr txBox="1"/>
          <p:nvPr/>
        </p:nvSpPr>
        <p:spPr>
          <a:xfrm>
            <a:off x="7319522" y="1237390"/>
            <a:ext cx="30532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From 45 days of age or earlier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62A7334-BE5B-A0A6-B365-BF0B83D33D49}"/>
              </a:ext>
            </a:extLst>
          </p:cNvPr>
          <p:cNvSpPr txBox="1"/>
          <p:nvPr/>
        </p:nvSpPr>
        <p:spPr>
          <a:xfrm>
            <a:off x="7257729" y="2376397"/>
            <a:ext cx="30532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About 45 days of age and later</a:t>
            </a:r>
            <a:endParaRPr lang="zh-CN" altLang="en-US" dirty="0"/>
          </a:p>
        </p:txBody>
      </p:sp>
      <p:sp>
        <p:nvSpPr>
          <p:cNvPr id="22" name="矩形: 圆角 21">
            <a:extLst>
              <a:ext uri="{FF2B5EF4-FFF2-40B4-BE49-F238E27FC236}">
                <a16:creationId xmlns:a16="http://schemas.microsoft.com/office/drawing/2014/main" id="{3C956053-1B89-610E-9DE4-3CA4627A3F48}"/>
              </a:ext>
            </a:extLst>
          </p:cNvPr>
          <p:cNvSpPr/>
          <p:nvPr/>
        </p:nvSpPr>
        <p:spPr>
          <a:xfrm>
            <a:off x="4435364" y="3556822"/>
            <a:ext cx="2858812" cy="529066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/>
              <a:t>Gouty kidney</a:t>
            </a:r>
            <a:endParaRPr lang="zh-CN" altLang="en-US" b="1" dirty="0"/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2F6678C8-2B77-90BA-8553-7D2B22B72454}"/>
              </a:ext>
            </a:extLst>
          </p:cNvPr>
          <p:cNvSpPr/>
          <p:nvPr/>
        </p:nvSpPr>
        <p:spPr>
          <a:xfrm>
            <a:off x="4456387" y="4459855"/>
            <a:ext cx="2858812" cy="567458"/>
          </a:xfrm>
          <a:prstGeom prst="roundRect">
            <a:avLst/>
          </a:prstGeom>
          <a:solidFill>
            <a:srgbClr val="8B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/>
              <a:t>Atherosclerosis, hypertension </a:t>
            </a:r>
            <a:endParaRPr lang="zh-CN" altLang="en-US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2BAAFA2-0669-18A4-83ED-27CB6CC1AEBC}"/>
              </a:ext>
            </a:extLst>
          </p:cNvPr>
          <p:cNvSpPr txBox="1"/>
          <p:nvPr/>
        </p:nvSpPr>
        <p:spPr>
          <a:xfrm>
            <a:off x="7257729" y="3616532"/>
            <a:ext cx="30532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About 45 days of age and later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03A5330-471C-939D-78E1-206EE42C1954}"/>
              </a:ext>
            </a:extLst>
          </p:cNvPr>
          <p:cNvSpPr txBox="1"/>
          <p:nvPr/>
        </p:nvSpPr>
        <p:spPr>
          <a:xfrm>
            <a:off x="7257729" y="4642929"/>
            <a:ext cx="35209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About 360 days of age and later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2256BCE-E4F4-47E9-9C85-66BB9C66099A}"/>
              </a:ext>
            </a:extLst>
          </p:cNvPr>
          <p:cNvSpPr txBox="1"/>
          <p:nvPr/>
        </p:nvSpPr>
        <p:spPr>
          <a:xfrm>
            <a:off x="7278749" y="5521006"/>
            <a:ext cx="303223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About 450 days of age</a:t>
            </a:r>
            <a:endParaRPr lang="zh-CN" altLang="en-US" dirty="0"/>
          </a:p>
        </p:txBody>
      </p:sp>
      <p:sp>
        <p:nvSpPr>
          <p:cNvPr id="2" name="箭头: 虚尾 1">
            <a:extLst>
              <a:ext uri="{FF2B5EF4-FFF2-40B4-BE49-F238E27FC236}">
                <a16:creationId xmlns:a16="http://schemas.microsoft.com/office/drawing/2014/main" id="{CF72D97F-5BF8-EE3A-4D81-206A2401202C}"/>
              </a:ext>
            </a:extLst>
          </p:cNvPr>
          <p:cNvSpPr/>
          <p:nvPr/>
        </p:nvSpPr>
        <p:spPr>
          <a:xfrm rot="5400000">
            <a:off x="5660439" y="1637749"/>
            <a:ext cx="335095" cy="536027"/>
          </a:xfrm>
          <a:prstGeom prst="striped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箭头: 虚尾 2">
            <a:extLst>
              <a:ext uri="{FF2B5EF4-FFF2-40B4-BE49-F238E27FC236}">
                <a16:creationId xmlns:a16="http://schemas.microsoft.com/office/drawing/2014/main" id="{F29ECE45-4449-1AFA-584D-B4AD33578D95}"/>
              </a:ext>
            </a:extLst>
          </p:cNvPr>
          <p:cNvSpPr/>
          <p:nvPr/>
        </p:nvSpPr>
        <p:spPr>
          <a:xfrm rot="5400000">
            <a:off x="5660438" y="4987661"/>
            <a:ext cx="335095" cy="536027"/>
          </a:xfrm>
          <a:prstGeom prst="striped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箭头: 虚尾 3">
            <a:extLst>
              <a:ext uri="{FF2B5EF4-FFF2-40B4-BE49-F238E27FC236}">
                <a16:creationId xmlns:a16="http://schemas.microsoft.com/office/drawing/2014/main" id="{230B94CC-D642-2DEB-C485-FAF5D572A924}"/>
              </a:ext>
            </a:extLst>
          </p:cNvPr>
          <p:cNvSpPr/>
          <p:nvPr/>
        </p:nvSpPr>
        <p:spPr>
          <a:xfrm rot="5400000">
            <a:off x="5655350" y="4015334"/>
            <a:ext cx="335095" cy="536027"/>
          </a:xfrm>
          <a:prstGeom prst="striped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箭头: 虚尾 7">
            <a:extLst>
              <a:ext uri="{FF2B5EF4-FFF2-40B4-BE49-F238E27FC236}">
                <a16:creationId xmlns:a16="http://schemas.microsoft.com/office/drawing/2014/main" id="{27DAFA2F-6F12-1665-E796-51B246D83F4F}"/>
              </a:ext>
            </a:extLst>
          </p:cNvPr>
          <p:cNvSpPr/>
          <p:nvPr/>
        </p:nvSpPr>
        <p:spPr>
          <a:xfrm rot="5400000">
            <a:off x="5661452" y="3091184"/>
            <a:ext cx="335095" cy="536027"/>
          </a:xfrm>
          <a:prstGeom prst="striped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56061B6-8E4D-0906-AE1D-13E1547673FA}"/>
              </a:ext>
            </a:extLst>
          </p:cNvPr>
          <p:cNvSpPr txBox="1"/>
          <p:nvPr/>
        </p:nvSpPr>
        <p:spPr>
          <a:xfrm>
            <a:off x="7319522" y="392309"/>
            <a:ext cx="25445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2A2F45"/>
                </a:solidFill>
                <a:effectLst/>
                <a:latin typeface="PingFang SC"/>
              </a:rPr>
              <a:t>From birt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43244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</TotalTime>
  <Words>65</Words>
  <Application>Microsoft Office PowerPoint</Application>
  <PresentationFormat>宽屏</PresentationFormat>
  <Paragraphs>1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PingFang SC</vt:lpstr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段为钢</dc:creator>
  <cp:lastModifiedBy>段为钢</cp:lastModifiedBy>
  <cp:revision>26</cp:revision>
  <dcterms:created xsi:type="dcterms:W3CDTF">2025-02-21T06:28:36Z</dcterms:created>
  <dcterms:modified xsi:type="dcterms:W3CDTF">2025-07-08T05:40:08Z</dcterms:modified>
</cp:coreProperties>
</file>